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239625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14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9953" y="883861"/>
            <a:ext cx="9179719" cy="1880235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9953" y="2836605"/>
            <a:ext cx="9179719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8"/>
            </a:lvl3pPr>
            <a:lvl4pPr marL="1080135" indent="0" algn="ctr">
              <a:buNone/>
              <a:defRPr sz="1260"/>
            </a:lvl4pPr>
            <a:lvl5pPr marL="1440180" indent="0" algn="ctr">
              <a:buNone/>
              <a:defRPr sz="1260"/>
            </a:lvl5pPr>
            <a:lvl6pPr marL="1800225" indent="0" algn="ctr">
              <a:buNone/>
              <a:defRPr sz="1260"/>
            </a:lvl6pPr>
            <a:lvl7pPr marL="2160270" indent="0" algn="ctr">
              <a:buNone/>
              <a:defRPr sz="1260"/>
            </a:lvl7pPr>
            <a:lvl8pPr marL="2520315" indent="0" algn="ctr">
              <a:buNone/>
              <a:defRPr sz="1260"/>
            </a:lvl8pPr>
            <a:lvl9pPr marL="2880360" indent="0" algn="ctr">
              <a:buNone/>
              <a:defRPr sz="12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640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5807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58982" y="287536"/>
            <a:ext cx="2639169" cy="45768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1474" y="287536"/>
            <a:ext cx="7764512" cy="45768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5851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04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5099" y="1346419"/>
            <a:ext cx="10556677" cy="2246530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5099" y="3614203"/>
            <a:ext cx="10556677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8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401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8002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6027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2031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8036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768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1474" y="1437680"/>
            <a:ext cx="5201841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6310" y="1437680"/>
            <a:ext cx="5201841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6392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287536"/>
            <a:ext cx="10556677" cy="104388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3069" y="1323916"/>
            <a:ext cx="517793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3069" y="1972747"/>
            <a:ext cx="5177935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6310" y="1323916"/>
            <a:ext cx="520343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6310" y="1972747"/>
            <a:ext cx="5203435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077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952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4984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9" y="360045"/>
            <a:ext cx="3947597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3435" y="777597"/>
            <a:ext cx="6196310" cy="3837980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9" y="1620202"/>
            <a:ext cx="3947597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5732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9" y="360045"/>
            <a:ext cx="3947597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03435" y="777597"/>
            <a:ext cx="6196310" cy="3837980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40180" indent="0">
              <a:buNone/>
              <a:defRPr sz="1575"/>
            </a:lvl5pPr>
            <a:lvl6pPr marL="1800225" indent="0">
              <a:buNone/>
              <a:defRPr sz="1575"/>
            </a:lvl6pPr>
            <a:lvl7pPr marL="2160270" indent="0">
              <a:buNone/>
              <a:defRPr sz="1575"/>
            </a:lvl7pPr>
            <a:lvl8pPr marL="2520315" indent="0">
              <a:buNone/>
              <a:defRPr sz="1575"/>
            </a:lvl8pPr>
            <a:lvl9pPr marL="2880360" indent="0">
              <a:buNone/>
              <a:defRPr sz="157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9" y="1620202"/>
            <a:ext cx="3947597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66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1474" y="287536"/>
            <a:ext cx="10556677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1474" y="1437680"/>
            <a:ext cx="10556677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1474" y="5005626"/>
            <a:ext cx="275391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7C1D79-62EC-4E87-9F4F-CAFED38E36DB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54376" y="5005626"/>
            <a:ext cx="4130873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44235" y="5005626"/>
            <a:ext cx="275391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A3890-D072-41FC-BE11-AB77706ED4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334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20090" rtl="0" eaLnBrk="1" latinLnBrk="0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023" indent="-180023" algn="l" defTabSz="7200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4006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0011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6015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62020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98024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34029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70033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306038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80022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16027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288036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9347FB9E-8D48-45C6-981B-85138AB9E4D7}"/>
              </a:ext>
            </a:extLst>
          </p:cNvPr>
          <p:cNvSpPr/>
          <p:nvPr/>
        </p:nvSpPr>
        <p:spPr>
          <a:xfrm>
            <a:off x="304548" y="144149"/>
            <a:ext cx="11758863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 20         *        40         *        60         *        80         *       100         *       120         *       140         *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TGGCGCCGTCCAAGCAGTACGACGAGGGCGGGCAGCTCCAGCTCATGGAGGCCGACCGGGTCGAGGAGGAGGAGGAGTGCTTCGAGTCCATCGACAAGTTGATCTCGCAGGGAATAAACTCAGGAGACGTGAAGAAGCTGCAGGATGCG :  1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TGGCGCCGTCCAAGCAGTACGACGAGGGCGGGCAGCTCCAGCTCATGGAGGCCGACCGGGTCGAGGAGGAGGAGGAGTGCTTCGAGTCCATCGACAAGTTGATCTCGCAGGGAAT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TCAGGAGACGTGAAGAAGCTGCAGGATGCG :  1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TGGCGCCGTCCAAGCAGTACGACGAGGGCGGGCAGCTCCAGCTCATGGAGGCCGACCGGGT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GAGGAGGAGGAGTGCTTCGAGTCCATCGACAAGTTGATCTCGCAGGGAATAAACTCAGGAGACGTGAAGAAGCTGCAGGATGCG :  1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160         *       180         *       200         *       220         *       240         *       260         *       280         *       300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GGATCTACACTTGCAATGGGCTGATGATGCACACCAAGAAGAGCCTTACAGGGATTAAGGGCTTGTCTGAAGCAAAGGTTGATAAGATCTGCGAGGCTGCTGAAAAACTTCTGAGTCAGGGTTTCATGACAGGAAGTGATCTCCTTATT :  3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GGATCTACACTTGCAATGG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GATGATGCACACCAAGAAGAGCCTTACAGGGATTAAGGGCTTGTCTGAAGCAAAGGTTGATAAGATCTGCGAGGCTGCTGAAAAACTTCTGAGTCAGGGTTTCATGACAGGAAGTGATCTCCTTATT :  3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GGATCTACACTTGCAATGGGCTGATGATGCACACCAAGAAGAGCCTTACAGGGATTAAGGGCTTGTCTGAAGC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GTTGATAAGATCTG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GCTGCTGAAAAACTTCTGAGTCAGGGTTTCATGACAGGAAGTGATCTCCTTATT :  3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320         *       340         *       360         *       380         *       400         *       420         *       440         *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AGCGAAAGTCTGTTGTCCGGATTACCACTGGGAGCCAAGCGCTTGATGAGCTGCTTGGAGGAGGGATTGAAACACTCTGTATCACAGAGGCATTTGGAGAGTTCCGGTCAGGGAAGACCCAGTTGGCTCATACTCTTTGTGTCTCCACT :  4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AGCGAAAGTCTGTTGTCCGGATTACCACTGGGAGCCAAGCGCTTGATGAGCTGCTTGGAGGAGGGATTGAAACACTCTGTATCACAGAGGCATTTGGAGAGTTCCGGTCAGGGAAGACCCAGTTGGCTCATACTCTTTGTGTCTCCACT :  4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AGCGAAAGTCTGTTGTCCGGATTACCACTGGGAGCCAA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CTTGATGAGCTGCTTGGAGGAGGGATTGAAACACTCTGTATCACAGAGGCATTTGGAGAGTTCCGGTCAGGGAAGACCCAGTTGGCTCATACTCTTTGTGTCTCCACT :  4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460         *       480         *       500         *       520         *       540         *       560         *       580         *       600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AGCTTCCACTCCACATGCATGGTGGGAACGGGAAGGTTGCCTACATTGACACTGAGGGAACATTCCGGCCTGAACGCATTGTGCCAATTGCTGAGAGATTTGGGATGGATGCCAATGCTGTTCTTGACAATATCATATACGCTCGCGCA :  6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AGCTTCCACTCCATATGCATGGTGGGAACGGGAAGGTTGCCTACATTG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TGAGGGAAC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CGGCCTGAACGCATTGTGCCAATTGCTGAGAGATTTGGGATGGATGCCAATGCTGTTCTTGACAATATCATATACGCTCGTGCA :  6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AGCTTCCACTCCA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CATGGTGGGAACGGGAAGGTTGCCTACATTGACACTGAGGGAACATTCCGGCCTGAACGCATTGTGCCAATTGCTGAGAGATTTGGGATGGATGCCAATGCTGTTCTTGACAATATCATATA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CGTGC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6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620         *       640         *       660         *       680         *       700         *       720         *       740         *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TACACCTATGAGCACCAGTACAACTTACTCCTGGGCCTTGCTGCCAAGATGGC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AGAGCCTTTCAGGCTTCTGATCGTGGATTCTGTGATTGCGCTATTCCGTGTTGATTTCAGTGGTAGGGGTGAACTTGCAGAGCGTCAGCAAAAA :  7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TACACCTATGAGCACCAGTACAACTTACTCCTGGGCCTTG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CCAAGATGGCTGAAGAGCCTTTCAGGCTTCTGATCGTGGATTCTGTGATTGCGCTATTCCGTGTTGATTTCAGTGG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GGGTGAACTTGCAGAGCGTCAGCAAAAA :  7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TACACCTATGAGCACCAGTACAACTTACTCCTGGGCCTTGCTGCCAAGATGGCTGAAGAGCCTTTCAGGCTTCTGATCGTGGATTCTGTGATTGCGCT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CGTGTTGATTTCAGTGGTAGGGGTGAACTTGCAGAGCGTCAGCAAAA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75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760         *       780         *       800         *       820         *       840         *       860         *       880         *       900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TGGCACAAATGCTGTCCCGCCTTACAAAGATTGCTGAGGAGTTCAATGTTGCAGTGTACATCACCAACCAAGTGATTGCGGACCCAGGTGGTGGTATGTTCATCACTGACCCCAAAAAGCCGGC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AGGCCACGTGCTGGCGCATGCA :  9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TGGCACAAATGCT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CGCCTTACAAAGATTGCTGAGGAGTTCAATGTTGCAGTGTACATCACCAACCAAGTGATTGCGGACCCAGGTGGTGGTATGTTCATCACTGACCCCAAAAAGCCGGCGGGAGGCCACGTGCTGGCGCATGCA :  9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TGGCACAAATGCTGTCCCGCCTTACAAAGATTGCTGAGGAGTTCAATGTTGCAGTGTACATCACCAACCAAGTGATTGCGGACCCAGGTGGTGGTATGTTCATCACTGACCCCAAAAAGCCGGCGGGAGGCCACGTGCTGGCGCATGCA :  900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920         *       940         *       960         *       980         *      1000         *      1020         *            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CCACCATCCGGTTGATGCTGAGGAAA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AAGGCGAGCAGCGTGTCTGCAAGATCTTTGACGCCCCTAACCTTCCCGAGGGAGAAGCTGTTTTCCAGATTACAACAGGCGGATTGATGGATGTGAAAGACTGA : 1035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CCACCATCCGGTTGATGCTGAGGAAAGGCAAAGGCGAGCAGCGT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TGCAAGATCTTTGACGCCCCTAACCTTCCCGAGGGAGAAGCTGTTTTCCAGATTACAACAGG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ATTGATGGATGTGAAAGACTGA : 1035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9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CCACCATCCGGTTGATGCTGAGGAAAGGCAAAGGCGAGCAGCGTGTCTGCAAGATCTTTGACGCCCCTAACCTTCCCGAGGGAGAAGCTGTTTTCCAGAT</a:t>
            </a:r>
            <a:r>
              <a:rPr lang="en-GB" sz="900" b="1" dirty="0">
                <a:solidFill>
                  <a:srgbClr val="FF0000"/>
                </a:solidFill>
                <a:highlight>
                  <a:srgbClr val="D3D3D3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ACAGGCGGATTGATGGATGTGAAAGACTGA : 1035</a:t>
            </a:r>
            <a:br>
              <a:rPr lang="en-GB" sz="9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2201129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ul Kader Alabdullah (JIC)</dc:creator>
  <cp:lastModifiedBy>Tracie Draeger (JIC)</cp:lastModifiedBy>
  <cp:revision>1</cp:revision>
  <dcterms:created xsi:type="dcterms:W3CDTF">2019-09-12T10:41:10Z</dcterms:created>
  <dcterms:modified xsi:type="dcterms:W3CDTF">2019-09-12T10:46:19Z</dcterms:modified>
</cp:coreProperties>
</file>